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60"/>
    <p:restoredTop sz="94586"/>
  </p:normalViewPr>
  <p:slideViewPr>
    <p:cSldViewPr snapToGrid="0" snapToObjects="1">
      <p:cViewPr varScale="1">
        <p:scale>
          <a:sx n="99" d="100"/>
          <a:sy n="99" d="100"/>
        </p:scale>
        <p:origin x="184" y="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D548A4-465D-EE42-812F-B791476D3B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5AB420F-23DD-9D42-B97E-FB768F3962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C119B5-7056-E340-BB6A-DE815C2E6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15B718-9BF7-1743-A922-1AF5C2CF3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DEC0CC-126D-C149-930B-C58212F43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274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602A5-54BE-514B-9E84-E3FEF5D382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D3FA37-B28B-DF46-954D-36D7AF76F5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A3169B-B3A2-A54E-9FE6-6F209E6D0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65FF5E-89B3-2443-A04B-9B161873E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B73B5-63A2-8F4D-9A51-82BDDBCFA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861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4E207E-36CB-B040-8CE8-79861F0389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A055A4-DD0A-554D-8747-5FC149CFDE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1C6EA1-5114-9841-84CB-48E077794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29F46C-3AF9-B34D-9071-FDB4F94AD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BC598F-77B9-C84E-A795-9F700A7B4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283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B29E1-85BA-7A4A-80DD-4125023164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BAE8CA-EF43-9A4D-B240-B8888E46DF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43D6F-50C3-4C41-B2C1-E7A626BA7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BD63C-25F8-0A49-8150-11ACB781BD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D07BF-5AAE-0E4D-A2FD-97F4559FF0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339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BF67A1-AE81-E14C-AB88-03212CC564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89ABED-9FFD-164A-9EF3-95DBB552B0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DBCF0E-1251-9442-9A9D-D26460DD4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7EC737-E53E-EA43-A003-38EE632A8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69436B-2957-E24C-BCC1-2B6CA1DB1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950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085E3D-A443-1D4E-82C1-558E976F7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BCA393-D303-E243-B73D-897ECD0A7D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38A36D-6C5E-0040-A420-D30D92D9AE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17EAD9-19FF-834D-8C7C-97CCE5EDF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B55A4D-36EE-8C41-BDEF-BAA7CF2C3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0E909B-F753-3044-849A-06DE88B9E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406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EE376B-360C-0347-8033-71DB025E1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1184C7-875A-2C45-A624-9EC813DDF1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6799EC-432B-D141-B5DF-FB90345BD2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439C70-1EBD-594C-8539-7E3ABB8C99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33CFAA-0B95-8C4F-92CB-0D49A72231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82E393-7EF5-6845-B89F-52BFECD7F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144727-6C0D-F747-B9ED-4B52294A0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5DC6DE-5E3F-5E43-B379-E8EEFAA27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52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FBC66-EB21-904B-A096-F91FEA2EF7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450153-A017-E74E-8715-27270E31A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8BADCB-F6AA-1A41-A357-5550FB696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F08B9C9-6403-D24E-AF2F-2CA7879A7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137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D4E7D2-9B26-F842-B408-65D24CFA5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9FE6191-D6E8-AC48-841D-E15EF54DC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0E6C42-E6D8-C841-B1AF-83F27D69C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42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E033DA-493F-CD4E-AEAE-7B0B131FD0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9FE273-1A3E-F44F-8190-285042290C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FBB10D-2810-5145-870A-C7C95F8FD2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3610DE-CD12-EE44-A8A5-6A7DB72CC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CDD04E-9407-5644-8A9D-523056AC5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00F744-0824-CB46-8D5F-3CED50FD1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137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3CF782-2102-F941-8ABF-2F439F9C5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10962A-97C8-1744-B220-80CC74082C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CDDE0D-36C5-AB4E-9963-26D86F9C9D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B88D3F-FDB8-A042-AFD5-C919E0C64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1A87FE-9E02-9243-BF47-B3865D787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56CBD3-B765-A44C-96FB-DC9FE2873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911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066D1A-F9F4-694D-9F27-1AA0EF7988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3341A4-B9F3-C645-930C-E4091C936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20BAE5-28E6-6D43-A0B1-877CCC59D1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B3D03-A774-404B-B001-6E5B453DAF60}" type="datetimeFigureOut">
              <a:rPr lang="en-US" smtClean="0"/>
              <a:t>2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EBBB08-0635-C245-A7BB-28563DEE45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BC6501-F524-B347-B0C9-51BE17481D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2A2B7-C996-4243-887B-E96F2ED24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206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3FADC-0747-4685-ABC4-59CE909B9B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CO" dirty="0"/>
              <a:t>CIBER </a:t>
            </a:r>
            <a:r>
              <a:rPr lang="es-CO" dirty="0" err="1"/>
              <a:t>Analysis</a:t>
            </a:r>
            <a:endParaRPr lang="en-CA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11655F-2649-43CF-AAAE-EEEA410D8C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CIBER is a data visualization method that presents different information on a diamond plot to facilitate the selection of the sub-determinants for intervention development. The diamond plot is divided into a left-hand panel and right-hand panels with diamonds. One diamond shape in </a:t>
            </a:r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left-hand panel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presents both the means of the sub-determinants (in this study, the CFIR-TDF items) and its 99.99% confidence interval. While each diamond in the </a:t>
            </a:r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ght-hand panel 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ents the associations (e.g., correlation) between the items and the outcome variables (In this study the intention offer </a:t>
            </a:r>
            <a:r>
              <a:rPr lang="en-CA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P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yellow line and advocate for </a:t>
            </a:r>
            <a:r>
              <a:rPr lang="en-CA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P</a:t>
            </a:r>
            <a:r>
              <a:rPr lang="en-CA" sz="18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urple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ine) with a 95% confidence interval. The dots around the left-hand panel diamonds are all the participants’ item scores. At the top of the plot, the confidence interval of the explained variance (R</a:t>
            </a:r>
            <a:r>
              <a:rPr lang="en-CA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both variables. </a:t>
            </a:r>
            <a:endParaRPr lang="en-CA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0543728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7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0A2EB5FC-EEED-604E-86C1-8B06AE4A18A3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68300" y="279400"/>
            <a:ext cx="8369300" cy="6108700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84E2450-7E12-DA4B-9C32-ECB5EF216B38}"/>
              </a:ext>
            </a:extLst>
          </p:cNvPr>
          <p:cNvCxnSpPr/>
          <p:nvPr/>
        </p:nvCxnSpPr>
        <p:spPr>
          <a:xfrm>
            <a:off x="7302500" y="6604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64BA7076-D127-314A-A41C-1B48C90B7F49}"/>
              </a:ext>
            </a:extLst>
          </p:cNvPr>
          <p:cNvSpPr txBox="1"/>
          <p:nvPr/>
        </p:nvSpPr>
        <p:spPr>
          <a:xfrm>
            <a:off x="9474200" y="825500"/>
            <a:ext cx="22479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9. CIBER analysis of beliefs about consequences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41305742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8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F0BB1A8B-8691-4841-B290-7746EE63AB06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31800" y="241300"/>
            <a:ext cx="8636000" cy="6350000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B77CAD17-62D5-FA43-B9C4-1BFABB60A70E}"/>
              </a:ext>
            </a:extLst>
          </p:cNvPr>
          <p:cNvCxnSpPr/>
          <p:nvPr/>
        </p:nvCxnSpPr>
        <p:spPr>
          <a:xfrm>
            <a:off x="7747000" y="6731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D2D43613-589B-5940-9712-1B3E72584FFD}"/>
              </a:ext>
            </a:extLst>
          </p:cNvPr>
          <p:cNvSpPr txBox="1"/>
          <p:nvPr/>
        </p:nvSpPr>
        <p:spPr>
          <a:xfrm>
            <a:off x="9474200" y="825500"/>
            <a:ext cx="22479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10. CIBER analysis of individual items  that did not fit in any scale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31023380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9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C2E2AB73-997A-384C-B83B-ACA84D909A6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914400" y="927099"/>
            <a:ext cx="4864100" cy="3632835"/>
          </a:xfrm>
          <a:prstGeom prst="rect">
            <a:avLst/>
          </a:prstGeom>
        </p:spPr>
      </p:pic>
      <p:pic>
        <p:nvPicPr>
          <p:cNvPr id="3" name="Imagen 20" descr="Gráfico&#10;&#10;Descripción generada automáticamente">
            <a:extLst>
              <a:ext uri="{FF2B5EF4-FFF2-40B4-BE49-F238E27FC236}">
                <a16:creationId xmlns:a16="http://schemas.microsoft.com/office/drawing/2014/main" id="{56F75FC7-DBAC-0846-A3F1-4564108D3C03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6248400" y="1091882"/>
            <a:ext cx="5549900" cy="3303268"/>
          </a:xfrm>
          <a:prstGeom prst="rect">
            <a:avLst/>
          </a:prstGeom>
        </p:spPr>
      </p:pic>
      <p:pic>
        <p:nvPicPr>
          <p:cNvPr id="4" name="Imagen 20" descr="Gráfico&#10;&#10;Descripción generada automáticamente">
            <a:extLst>
              <a:ext uri="{FF2B5EF4-FFF2-40B4-BE49-F238E27FC236}">
                <a16:creationId xmlns:a16="http://schemas.microsoft.com/office/drawing/2014/main" id="{897B0F5B-A8CF-4847-A89A-283B42CC5A92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6248400" y="927098"/>
            <a:ext cx="5549900" cy="3632835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632D2C56-E929-FE40-BFC3-B4B0D5C8FBE2}"/>
              </a:ext>
            </a:extLst>
          </p:cNvPr>
          <p:cNvCxnSpPr>
            <a:cxnSpLocks/>
          </p:cNvCxnSpPr>
          <p:nvPr/>
        </p:nvCxnSpPr>
        <p:spPr>
          <a:xfrm>
            <a:off x="5080000" y="1231900"/>
            <a:ext cx="0" cy="30734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4DB1F18-5A71-BB45-82C4-E42E577043CB}"/>
              </a:ext>
            </a:extLst>
          </p:cNvPr>
          <p:cNvCxnSpPr>
            <a:cxnSpLocks/>
          </p:cNvCxnSpPr>
          <p:nvPr/>
        </p:nvCxnSpPr>
        <p:spPr>
          <a:xfrm>
            <a:off x="10998200" y="1091882"/>
            <a:ext cx="0" cy="321341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39070AF5-E48B-EC41-BA0C-EFC37857DBD3}"/>
              </a:ext>
            </a:extLst>
          </p:cNvPr>
          <p:cNvSpPr txBox="1"/>
          <p:nvPr/>
        </p:nvSpPr>
        <p:spPr>
          <a:xfrm>
            <a:off x="2442335" y="4779314"/>
            <a:ext cx="73713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12. CIBER analysis of individual items  that did not fit in any scale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37826063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1" descr="Imagen que contiene Gráfico&#10;&#10;Descripción generada automáticamente">
            <a:extLst>
              <a:ext uri="{FF2B5EF4-FFF2-40B4-BE49-F238E27FC236}">
                <a16:creationId xmlns:a16="http://schemas.microsoft.com/office/drawing/2014/main" id="{5882FAC3-D23F-CC44-9D44-979D79C97E3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672860" y="207033"/>
            <a:ext cx="8394940" cy="626277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D05F2A3-4AA3-F741-8E7F-2C4E3C7425B9}"/>
              </a:ext>
            </a:extLst>
          </p:cNvPr>
          <p:cNvSpPr txBox="1"/>
          <p:nvPr/>
        </p:nvSpPr>
        <p:spPr>
          <a:xfrm>
            <a:off x="9474200" y="825500"/>
            <a:ext cx="22479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1. CIBER analysis of each of the items of characteristics of the intervention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78B35B3-DE38-AC4F-9794-9728233D4BE6}"/>
              </a:ext>
            </a:extLst>
          </p:cNvPr>
          <p:cNvCxnSpPr/>
          <p:nvPr/>
        </p:nvCxnSpPr>
        <p:spPr>
          <a:xfrm>
            <a:off x="8039100" y="5969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499254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2" descr="Gráfico&#10;&#10;Descripción generada automáticamente">
            <a:extLst>
              <a:ext uri="{FF2B5EF4-FFF2-40B4-BE49-F238E27FC236}">
                <a16:creationId xmlns:a16="http://schemas.microsoft.com/office/drawing/2014/main" id="{E3C979AB-95B9-FA4A-AAC8-FB73E9818E4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52091" y="258793"/>
            <a:ext cx="8515709" cy="6297282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CA1A98B-8DC1-D24A-B58F-2F666F5AE0B7}"/>
              </a:ext>
            </a:extLst>
          </p:cNvPr>
          <p:cNvCxnSpPr/>
          <p:nvPr/>
        </p:nvCxnSpPr>
        <p:spPr>
          <a:xfrm>
            <a:off x="7823200" y="6350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9BCCF84B-FFDB-40A6-B125-70CBFFE48514}"/>
              </a:ext>
            </a:extLst>
          </p:cNvPr>
          <p:cNvSpPr txBox="1"/>
          <p:nvPr/>
        </p:nvSpPr>
        <p:spPr>
          <a:xfrm>
            <a:off x="9474200" y="825500"/>
            <a:ext cx="22479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2. CIBER analysis of each of the items of attitudes towards needs of </a:t>
            </a:r>
            <a:r>
              <a:rPr lang="en-US" dirty="0" err="1"/>
              <a:t>PrEP</a:t>
            </a:r>
            <a:r>
              <a:rPr lang="en-US" dirty="0"/>
              <a:t>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9540076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3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5090E29B-9C7A-1B44-81C1-AD0F35F6CF5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31800" y="279400"/>
            <a:ext cx="8636000" cy="6083299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7C5C567-D395-F443-8A3A-0962B2818A8F}"/>
              </a:ext>
            </a:extLst>
          </p:cNvPr>
          <p:cNvCxnSpPr/>
          <p:nvPr/>
        </p:nvCxnSpPr>
        <p:spPr>
          <a:xfrm>
            <a:off x="7759700" y="5969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5921A966-2457-734E-A4F8-C64B3A1609BD}"/>
              </a:ext>
            </a:extLst>
          </p:cNvPr>
          <p:cNvSpPr txBox="1"/>
          <p:nvPr/>
        </p:nvSpPr>
        <p:spPr>
          <a:xfrm>
            <a:off x="9474200" y="825500"/>
            <a:ext cx="22479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. CIBER analysis of concerns of use in populations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10849596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4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0313DE02-5478-E24E-94DC-5D29EB043E14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96900" y="266700"/>
            <a:ext cx="8470900" cy="5981699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0216886-1929-9641-AEFB-3F064956A2C6}"/>
              </a:ext>
            </a:extLst>
          </p:cNvPr>
          <p:cNvCxnSpPr/>
          <p:nvPr/>
        </p:nvCxnSpPr>
        <p:spPr>
          <a:xfrm>
            <a:off x="7848600" y="4953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3DFB69C7-B891-AF48-AB34-2ADE8682BEC5}"/>
              </a:ext>
            </a:extLst>
          </p:cNvPr>
          <p:cNvSpPr txBox="1"/>
          <p:nvPr/>
        </p:nvSpPr>
        <p:spPr>
          <a:xfrm>
            <a:off x="9474200" y="825500"/>
            <a:ext cx="22479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4. CIBER analysis of concerns of health systems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4732806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5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B037091E-92E4-3F40-9BD9-428CD7FC7665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68300" y="215900"/>
            <a:ext cx="8699500" cy="6350000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C3330E9F-CB3A-5A48-85B2-B5A46968A824}"/>
              </a:ext>
            </a:extLst>
          </p:cNvPr>
          <p:cNvCxnSpPr/>
          <p:nvPr/>
        </p:nvCxnSpPr>
        <p:spPr>
          <a:xfrm>
            <a:off x="7747000" y="6604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16E037DF-0C54-F04A-A2A5-9D2BF86488A9}"/>
              </a:ext>
            </a:extLst>
          </p:cNvPr>
          <p:cNvSpPr txBox="1"/>
          <p:nvPr/>
        </p:nvSpPr>
        <p:spPr>
          <a:xfrm>
            <a:off x="9474200" y="825500"/>
            <a:ext cx="22479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5. CIBER analysis of knowledge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17677754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6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28831D42-23BF-6F4C-8D77-BACA5E69680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46100" y="304800"/>
            <a:ext cx="8521700" cy="6184899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BF16A28E-6CF9-BD45-87E0-48A468B79D58}"/>
              </a:ext>
            </a:extLst>
          </p:cNvPr>
          <p:cNvCxnSpPr/>
          <p:nvPr/>
        </p:nvCxnSpPr>
        <p:spPr>
          <a:xfrm>
            <a:off x="7645400" y="6350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8D7AA511-99CB-1B40-A61A-C304666D1FE4}"/>
              </a:ext>
            </a:extLst>
          </p:cNvPr>
          <p:cNvSpPr txBox="1"/>
          <p:nvPr/>
        </p:nvSpPr>
        <p:spPr>
          <a:xfrm>
            <a:off x="9474200" y="825500"/>
            <a:ext cx="22479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6. CIBER analysis of beliefs about capabilities 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35575079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5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839BBA75-D6AF-EE49-966B-551A1AC11F2A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30200" y="203200"/>
            <a:ext cx="8737600" cy="6451599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A1D9DD49-C95C-844C-846A-5F34B3B56D63}"/>
              </a:ext>
            </a:extLst>
          </p:cNvPr>
          <p:cNvCxnSpPr/>
          <p:nvPr/>
        </p:nvCxnSpPr>
        <p:spPr>
          <a:xfrm>
            <a:off x="7581900" y="6731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55E4DDEB-BEE6-3947-89D2-A53EC30F37D0}"/>
              </a:ext>
            </a:extLst>
          </p:cNvPr>
          <p:cNvSpPr txBox="1"/>
          <p:nvPr/>
        </p:nvSpPr>
        <p:spPr>
          <a:xfrm>
            <a:off x="9474200" y="825500"/>
            <a:ext cx="22479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7. CIBER analysis of professional role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28050208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6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AD5D0045-46B4-6142-B5AB-694EE74AFEC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84200" y="228600"/>
            <a:ext cx="8483600" cy="6197600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46A1A5F-CE94-464B-9CD4-0977848270D1}"/>
              </a:ext>
            </a:extLst>
          </p:cNvPr>
          <p:cNvCxnSpPr/>
          <p:nvPr/>
        </p:nvCxnSpPr>
        <p:spPr>
          <a:xfrm>
            <a:off x="7797800" y="635000"/>
            <a:ext cx="0" cy="553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5B509BE0-2212-164A-B778-E45E4D868964}"/>
              </a:ext>
            </a:extLst>
          </p:cNvPr>
          <p:cNvSpPr txBox="1"/>
          <p:nvPr/>
        </p:nvSpPr>
        <p:spPr>
          <a:xfrm>
            <a:off x="9474200" y="825500"/>
            <a:ext cx="22479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8. CIBER analysis of social influence and intention to offer </a:t>
            </a:r>
            <a:r>
              <a:rPr lang="en-US" dirty="0" err="1"/>
              <a:t>PrEP</a:t>
            </a:r>
            <a:r>
              <a:rPr lang="en-US" dirty="0"/>
              <a:t> and advocacy</a:t>
            </a:r>
          </a:p>
        </p:txBody>
      </p:sp>
    </p:spTree>
    <p:extLst>
      <p:ext uri="{BB962C8B-B14F-4D97-AF65-F5344CB8AC3E}">
        <p14:creationId xmlns:p14="http://schemas.microsoft.com/office/powerpoint/2010/main" val="2565366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</TotalTime>
  <Words>355</Words>
  <Application>Microsoft Macintosh PowerPoint</Application>
  <PresentationFormat>Widescreen</PresentationFormat>
  <Paragraphs>13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CIBER Analysi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triz Alvarado</dc:creator>
  <cp:lastModifiedBy>Beatriz Alvarado</cp:lastModifiedBy>
  <cp:revision>19</cp:revision>
  <dcterms:created xsi:type="dcterms:W3CDTF">2021-12-23T22:23:53Z</dcterms:created>
  <dcterms:modified xsi:type="dcterms:W3CDTF">2022-02-18T15:14:11Z</dcterms:modified>
</cp:coreProperties>
</file>